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23" r:id="rId2"/>
    <p:sldId id="324" r:id="rId3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21" userDrawn="1">
          <p15:clr>
            <a:srgbClr val="A4A3A4"/>
          </p15:clr>
        </p15:guide>
        <p15:guide id="2" pos="16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1DFDCD1-EF6B-3F80-07E7-35A56DD59C0E}" name="Charleen Chan" initials="CC" userId="S::charleen.chan@icr.ac.uk::73a26ce7-f665-4248-b705-b0b5a6e7a5b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050"/>
    <a:srgbClr val="FF6699"/>
    <a:srgbClr val="CC0000"/>
    <a:srgbClr val="CC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04"/>
    <p:restoredTop sz="92017"/>
  </p:normalViewPr>
  <p:slideViewPr>
    <p:cSldViewPr snapToGrid="0">
      <p:cViewPr>
        <p:scale>
          <a:sx n="204" d="100"/>
          <a:sy n="204" d="100"/>
        </p:scale>
        <p:origin x="680" y="144"/>
      </p:cViewPr>
      <p:guideLst>
        <p:guide orient="horz" pos="2621"/>
        <p:guide pos="1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224BE0-296C-2D4A-8E47-23328EA7FFFE}" type="datetimeFigureOut">
              <a:rPr lang="en-US" smtClean="0"/>
              <a:t>10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9F04B6-F912-E44D-B4F8-91F0A27773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9782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1936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560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9420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869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86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2442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570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7527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6618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911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507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6519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10" Type="http://schemas.openxmlformats.org/officeDocument/2006/relationships/image" Target="../media/image9.emf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293F949-F762-0330-5D72-63F0F2C641B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FD05956C-D85F-C766-3C9D-1A3FE6C85D07}"/>
              </a:ext>
            </a:extLst>
          </p:cNvPr>
          <p:cNvSpPr txBox="1"/>
          <p:nvPr/>
        </p:nvSpPr>
        <p:spPr>
          <a:xfrm>
            <a:off x="55817" y="30893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33D175C-094E-769F-6AD2-20EF87D181E4}"/>
              </a:ext>
            </a:extLst>
          </p:cNvPr>
          <p:cNvSpPr txBox="1"/>
          <p:nvPr/>
        </p:nvSpPr>
        <p:spPr>
          <a:xfrm>
            <a:off x="56326" y="496531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CEA3F79-FC67-DEA5-4050-45BB45C40AF0}"/>
              </a:ext>
            </a:extLst>
          </p:cNvPr>
          <p:cNvSpPr txBox="1"/>
          <p:nvPr/>
        </p:nvSpPr>
        <p:spPr>
          <a:xfrm>
            <a:off x="56088" y="253119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2C197EA-14F2-AAEF-220D-0EB03B839004}"/>
              </a:ext>
            </a:extLst>
          </p:cNvPr>
          <p:cNvSpPr txBox="1"/>
          <p:nvPr/>
        </p:nvSpPr>
        <p:spPr>
          <a:xfrm>
            <a:off x="3316956" y="253119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A8771C6-70EA-6AFF-4165-32AAEB33B833}"/>
              </a:ext>
            </a:extLst>
          </p:cNvPr>
          <p:cNvSpPr txBox="1"/>
          <p:nvPr/>
        </p:nvSpPr>
        <p:spPr>
          <a:xfrm>
            <a:off x="70081" y="7232434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264D610E-0D65-AD99-4790-C63AAB1E13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8751" y="7532960"/>
            <a:ext cx="2776919" cy="1564395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9BA19F95-B597-02E5-56CC-5350C8BCB8A9}"/>
              </a:ext>
            </a:extLst>
          </p:cNvPr>
          <p:cNvSpPr txBox="1"/>
          <p:nvPr/>
        </p:nvSpPr>
        <p:spPr>
          <a:xfrm>
            <a:off x="75122" y="7666625"/>
            <a:ext cx="460987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dirty="0"/>
              <a:t>10-</a:t>
            </a:r>
          </a:p>
          <a:p>
            <a:pPr algn="r"/>
            <a:endParaRPr lang="en-US" sz="900" dirty="0"/>
          </a:p>
          <a:p>
            <a:pPr algn="r"/>
            <a:endParaRPr lang="en-US" sz="900" dirty="0"/>
          </a:p>
          <a:p>
            <a:pPr algn="r"/>
            <a:r>
              <a:rPr lang="en-US" sz="600" dirty="0"/>
              <a:t>5-</a:t>
            </a:r>
          </a:p>
          <a:p>
            <a:pPr algn="r"/>
            <a:endParaRPr lang="en-US" sz="900" dirty="0"/>
          </a:p>
          <a:p>
            <a:pPr algn="r"/>
            <a:endParaRPr lang="en-US" sz="900" dirty="0"/>
          </a:p>
          <a:p>
            <a:pPr algn="r"/>
            <a:r>
              <a:rPr lang="en-US" sz="600" dirty="0"/>
              <a:t>0-</a:t>
            </a:r>
          </a:p>
          <a:p>
            <a:pPr algn="r"/>
            <a:endParaRPr lang="en-US" sz="900" dirty="0"/>
          </a:p>
          <a:p>
            <a:pPr algn="r"/>
            <a:endParaRPr lang="en-US" sz="900" dirty="0"/>
          </a:p>
          <a:p>
            <a:pPr algn="r"/>
            <a:r>
              <a:rPr lang="en-US" sz="600" dirty="0"/>
              <a:t>-5-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7361D05-2575-3985-CF97-D2083B03434E}"/>
              </a:ext>
            </a:extLst>
          </p:cNvPr>
          <p:cNvSpPr txBox="1"/>
          <p:nvPr/>
        </p:nvSpPr>
        <p:spPr>
          <a:xfrm>
            <a:off x="305615" y="9058020"/>
            <a:ext cx="27769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-5.0           -2.5              0              2.5.           5.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D515B32-5B74-7D45-A2B9-B5FAA8006BB8}"/>
              </a:ext>
            </a:extLst>
          </p:cNvPr>
          <p:cNvSpPr txBox="1"/>
          <p:nvPr/>
        </p:nvSpPr>
        <p:spPr>
          <a:xfrm>
            <a:off x="1692772" y="9058020"/>
            <a:ext cx="27769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-5.0           -2.5              0              2.5.           5.0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9E171AC5-E888-944A-DC52-86CB23676F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5101" y="7309843"/>
            <a:ext cx="3199948" cy="1990519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24013AD1-C93A-A132-D607-80CEA4D0FE6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73574" y="8614536"/>
            <a:ext cx="475817" cy="677588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EBC34234-ECDA-1649-738A-10D3376962D4}"/>
              </a:ext>
            </a:extLst>
          </p:cNvPr>
          <p:cNvSpPr txBox="1"/>
          <p:nvPr/>
        </p:nvSpPr>
        <p:spPr>
          <a:xfrm>
            <a:off x="305615" y="7305475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MOC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8280F18-9EF9-0CFD-38A7-4619DC22F0A8}"/>
              </a:ext>
            </a:extLst>
          </p:cNvPr>
          <p:cNvSpPr txBox="1"/>
          <p:nvPr/>
        </p:nvSpPr>
        <p:spPr>
          <a:xfrm rot="16200000">
            <a:off x="19489" y="8248807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UMAP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A691154-39A5-A3C5-64AB-FF627F5CA9EE}"/>
              </a:ext>
            </a:extLst>
          </p:cNvPr>
          <p:cNvSpPr txBox="1"/>
          <p:nvPr/>
        </p:nvSpPr>
        <p:spPr>
          <a:xfrm>
            <a:off x="1526317" y="9201497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>
                <a:latin typeface="Arial" panose="020B0604020202020204" pitchFamily="34" charset="0"/>
                <a:cs typeface="Arial" panose="020B0604020202020204" pitchFamily="34" charset="0"/>
              </a:rPr>
              <a:t>UMAP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ADC505E-8F48-5465-8D49-4EFC6A21BA3A}"/>
              </a:ext>
            </a:extLst>
          </p:cNvPr>
          <p:cNvSpPr txBox="1"/>
          <p:nvPr/>
        </p:nvSpPr>
        <p:spPr>
          <a:xfrm>
            <a:off x="3305366" y="724016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1746DF4-B4D3-D3B8-2F8C-DF0EDDB41DFB}"/>
              </a:ext>
            </a:extLst>
          </p:cNvPr>
          <p:cNvSpPr txBox="1"/>
          <p:nvPr/>
        </p:nvSpPr>
        <p:spPr>
          <a:xfrm>
            <a:off x="2847722" y="31736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651A9A2-CEC0-0E2F-CFE2-BE154A39E34C}"/>
              </a:ext>
            </a:extLst>
          </p:cNvPr>
          <p:cNvSpPr txBox="1"/>
          <p:nvPr/>
        </p:nvSpPr>
        <p:spPr>
          <a:xfrm>
            <a:off x="4783634" y="4708908"/>
            <a:ext cx="304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9DADD3D-2FC8-7490-0BD3-A428D19A4E1F}"/>
              </a:ext>
            </a:extLst>
          </p:cNvPr>
          <p:cNvSpPr txBox="1"/>
          <p:nvPr/>
        </p:nvSpPr>
        <p:spPr>
          <a:xfrm>
            <a:off x="5883966" y="67753"/>
            <a:ext cx="1233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B0FE2BF-CC5F-7F3D-8253-C85277B862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4801" y="428369"/>
            <a:ext cx="2669060" cy="187919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1C25B98-D20A-8620-75CE-397AD77AC10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30604" y="329513"/>
            <a:ext cx="2711581" cy="225218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57CDC5D-68A6-417E-280D-378A2956CCF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8922" y="2586680"/>
            <a:ext cx="2964197" cy="2336285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08D39830-7127-B34E-040C-362EFDA9086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6561" y="5033320"/>
            <a:ext cx="5009110" cy="209571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00FD8BAE-98B7-3E27-A8B0-02FEB91F7F7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40411" y="4771073"/>
            <a:ext cx="1717589" cy="1849229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15A5922-B1B1-1E7D-9D7C-768C9872B61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57598" y="2678792"/>
            <a:ext cx="3068595" cy="18188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04241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E12550B-B80E-B04D-AD42-F20963B708A0}"/>
              </a:ext>
            </a:extLst>
          </p:cNvPr>
          <p:cNvSpPr txBox="1"/>
          <p:nvPr/>
        </p:nvSpPr>
        <p:spPr>
          <a:xfrm>
            <a:off x="413951" y="278027"/>
            <a:ext cx="601774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n vivo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tudies of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xevinapant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in combination with RT or CRT in the MOC1 model. A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reatment schematic for MOC1. C57BL/6 mice were implanted with MOC1 cells (4 × 10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 subcutaneously in right flank. Treatment included cisplatin (5 mg/kg, intraperitoneal), RT (6 Gy × 3 on alternate days), and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xevinapant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100 mg/kg, oral gavage, 5 consecutive days per week for three weeks). Mice were monitored for tumour growth and survival; or collected for downstream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immunoprofiling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10-14 mice/group)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B-C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verage tumour growth curves across different conditions.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D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 Individual tumour growth curves across different treatment conditions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Kaplan–Meier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survival curves across different conditions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Quantification of number of CD8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T-cells per mg tumour using flow cytometry under indicated treatment conditions (7-10 mice/group)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G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UMAP plot of MOC1 CD8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TILs show clusters 1-9 for treatment groups CRT plus vehicle versus CRT plus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xevinapant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H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istograms illustrate the indicated marker expression for each cluster, with results concatenated from 27 mice. All data representative of 2 independent experiments.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Images for A created with </a:t>
            </a:r>
            <a:r>
              <a:rPr lang="en-GB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Biorender.com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9480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34</TotalTime>
  <Words>256</Words>
  <Application>Microsoft Macintosh PowerPoint</Application>
  <PresentationFormat>A4 Paper (210x297 mm)</PresentationFormat>
  <Paragraphs>2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nuel Patin</dc:creator>
  <cp:lastModifiedBy>Charleen Chan</cp:lastModifiedBy>
  <cp:revision>535</cp:revision>
  <cp:lastPrinted>2025-06-25T15:47:08Z</cp:lastPrinted>
  <dcterms:created xsi:type="dcterms:W3CDTF">2019-11-04T10:33:30Z</dcterms:created>
  <dcterms:modified xsi:type="dcterms:W3CDTF">2025-10-09T08:53:36Z</dcterms:modified>
</cp:coreProperties>
</file>